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94" d="100"/>
          <a:sy n="94" d="100"/>
        </p:scale>
        <p:origin x="226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Paldfs12\home$\HRPTMF\My%20Documents\apple\starch&amp;sugar\Grafted%20Trees%20Sugar%20Starch%20Measurements08%2016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Paldfs12\home$\HRPTMF\My%20Documents\apple\starch&amp;sugar\Grafted%20Trees%20Sugar%20Starch%20Measurements08%2016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NZ"/>
              <a:t>Sucrose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'M9'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graphs!$M$5,graphs!$M$7,graphs!$M$9)</c:f>
                <c:numCache>
                  <c:formatCode>General</c:formatCode>
                  <c:ptCount val="3"/>
                  <c:pt idx="0">
                    <c:v>0.56639586218481475</c:v>
                  </c:pt>
                  <c:pt idx="1">
                    <c:v>0.64760511721799863</c:v>
                  </c:pt>
                  <c:pt idx="2">
                    <c:v>0.37640194242247693</c:v>
                  </c:pt>
                </c:numCache>
              </c:numRef>
            </c:plus>
            <c:minus>
              <c:numRef>
                <c:f>(graphs!$M$5,graphs!$M$7,graphs!$M$9)</c:f>
                <c:numCache>
                  <c:formatCode>General</c:formatCode>
                  <c:ptCount val="3"/>
                  <c:pt idx="0">
                    <c:v>0.56639586218481475</c:v>
                  </c:pt>
                  <c:pt idx="1">
                    <c:v>0.64760511721799863</c:v>
                  </c:pt>
                  <c:pt idx="2">
                    <c:v>0.3764019424224769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graphs!$A$4,graphs!$A$6,graphs!$A$8)</c:f>
              <c:strCache>
                <c:ptCount val="3"/>
                <c:pt idx="0">
                  <c:v>Roots </c:v>
                </c:pt>
                <c:pt idx="1">
                  <c:v>Rootstock stem</c:v>
                </c:pt>
                <c:pt idx="2">
                  <c:v>'RG' scion</c:v>
                </c:pt>
              </c:strCache>
            </c:strRef>
          </c:cat>
          <c:val>
            <c:numRef>
              <c:f>(graphs!$M$4,graphs!$M$6,graphs!$M$8)</c:f>
              <c:numCache>
                <c:formatCode>0.00</c:formatCode>
                <c:ptCount val="3"/>
                <c:pt idx="0">
                  <c:v>6.6175639346503807</c:v>
                </c:pt>
                <c:pt idx="1">
                  <c:v>6.038109878338445</c:v>
                </c:pt>
                <c:pt idx="2">
                  <c:v>4.6926147844691926</c:v>
                </c:pt>
              </c:numCache>
            </c:numRef>
          </c:val>
        </c:ser>
        <c:ser>
          <c:idx val="1"/>
          <c:order val="1"/>
          <c:tx>
            <c:v>'RG'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graphs!$N$5,graphs!$N$7,graphs!$N$9)</c:f>
                <c:numCache>
                  <c:formatCode>General</c:formatCode>
                  <c:ptCount val="3"/>
                  <c:pt idx="0">
                    <c:v>0.93882252508874342</c:v>
                  </c:pt>
                  <c:pt idx="1">
                    <c:v>0.4605118218561281</c:v>
                  </c:pt>
                  <c:pt idx="2">
                    <c:v>0.30234726175862497</c:v>
                  </c:pt>
                </c:numCache>
              </c:numRef>
            </c:plus>
            <c:minus>
              <c:numRef>
                <c:f>(graphs!$N$5,graphs!$N$7,graphs!$N$9)</c:f>
                <c:numCache>
                  <c:formatCode>General</c:formatCode>
                  <c:ptCount val="3"/>
                  <c:pt idx="0">
                    <c:v>0.93882252508874342</c:v>
                  </c:pt>
                  <c:pt idx="1">
                    <c:v>0.4605118218561281</c:v>
                  </c:pt>
                  <c:pt idx="2">
                    <c:v>0.302347261758624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graphs!$A$4,graphs!$A$6,graphs!$A$8)</c:f>
              <c:strCache>
                <c:ptCount val="3"/>
                <c:pt idx="0">
                  <c:v>Roots </c:v>
                </c:pt>
                <c:pt idx="1">
                  <c:v>Rootstock stem</c:v>
                </c:pt>
                <c:pt idx="2">
                  <c:v>'RG' scion</c:v>
                </c:pt>
              </c:strCache>
            </c:strRef>
          </c:cat>
          <c:val>
            <c:numRef>
              <c:f>(graphs!$N$4,graphs!$N$6,graphs!$N$8)</c:f>
              <c:numCache>
                <c:formatCode>0.00</c:formatCode>
                <c:ptCount val="3"/>
                <c:pt idx="0">
                  <c:v>7.042282615248852</c:v>
                </c:pt>
                <c:pt idx="1">
                  <c:v>4.7767068183726193</c:v>
                </c:pt>
                <c:pt idx="2">
                  <c:v>5.125623903654434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71121048"/>
        <c:axId val="371121440"/>
      </c:barChart>
      <c:catAx>
        <c:axId val="3711210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71121440"/>
        <c:crosses val="autoZero"/>
        <c:auto val="1"/>
        <c:lblAlgn val="ctr"/>
        <c:lblOffset val="100"/>
        <c:noMultiLvlLbl val="0"/>
      </c:catAx>
      <c:valAx>
        <c:axId val="3711214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711210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r"/>
      <c:layout/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NZ"/>
              <a:t>Galactose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raphs!$C$3</c:f>
              <c:strCache>
                <c:ptCount val="1"/>
                <c:pt idx="0">
                  <c:v>'M9'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graphs!$Q$5,graphs!$Q$7,graphs!$Q$9)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.1447150061997697E-2</c:v>
                  </c:pt>
                  <c:pt idx="2">
                    <c:v>1.2698025362397669E-2</c:v>
                  </c:pt>
                </c:numCache>
              </c:numRef>
            </c:plus>
            <c:minus>
              <c:numRef>
                <c:f>(graphs!$Q$5,graphs!$Q$7,graphs!$Q$9)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.1447150061997697E-2</c:v>
                  </c:pt>
                  <c:pt idx="2">
                    <c:v>1.269802536239766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graphs!$A$4,graphs!$A$6,graphs!$A$8)</c:f>
              <c:strCache>
                <c:ptCount val="3"/>
                <c:pt idx="0">
                  <c:v>Roots </c:v>
                </c:pt>
                <c:pt idx="1">
                  <c:v>Rootstock stem</c:v>
                </c:pt>
                <c:pt idx="2">
                  <c:v>'RG' scion</c:v>
                </c:pt>
              </c:strCache>
            </c:strRef>
          </c:cat>
          <c:val>
            <c:numRef>
              <c:f>(graphs!$Q$4,graphs!$Q$6,graphs!$Q$8)</c:f>
              <c:numCache>
                <c:formatCode>General</c:formatCode>
                <c:ptCount val="3"/>
                <c:pt idx="0">
                  <c:v>0</c:v>
                </c:pt>
                <c:pt idx="1">
                  <c:v>5.1423664086346597E-2</c:v>
                </c:pt>
                <c:pt idx="2">
                  <c:v>8.0137291132944807E-2</c:v>
                </c:pt>
              </c:numCache>
            </c:numRef>
          </c:val>
        </c:ser>
        <c:ser>
          <c:idx val="1"/>
          <c:order val="1"/>
          <c:tx>
            <c:strRef>
              <c:f>graphs!$D$3</c:f>
              <c:strCache>
                <c:ptCount val="1"/>
                <c:pt idx="0">
                  <c:v>'RG'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graphs!$R$5,graphs!$R$7,graphs!$R$9)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.339577539007997E-2</c:v>
                  </c:pt>
                  <c:pt idx="2">
                    <c:v>1.2924798507802406E-2</c:v>
                  </c:pt>
                </c:numCache>
              </c:numRef>
            </c:plus>
            <c:minus>
              <c:numRef>
                <c:f>(graphs!$R$5,graphs!$R$7,graphs!$R$9)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.339577539007997E-2</c:v>
                  </c:pt>
                  <c:pt idx="2">
                    <c:v>1.292479850780240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graphs!$A$4,graphs!$A$6,graphs!$A$8)</c:f>
              <c:strCache>
                <c:ptCount val="3"/>
                <c:pt idx="0">
                  <c:v>Roots </c:v>
                </c:pt>
                <c:pt idx="1">
                  <c:v>Rootstock stem</c:v>
                </c:pt>
                <c:pt idx="2">
                  <c:v>'RG' scion</c:v>
                </c:pt>
              </c:strCache>
            </c:strRef>
          </c:cat>
          <c:val>
            <c:numRef>
              <c:f>(graphs!$R$4,graphs!$R$6,graphs!$R$8)</c:f>
              <c:numCache>
                <c:formatCode>General</c:formatCode>
                <c:ptCount val="3"/>
                <c:pt idx="0">
                  <c:v>0</c:v>
                </c:pt>
                <c:pt idx="1">
                  <c:v>6.6417991672860721E-2</c:v>
                </c:pt>
                <c:pt idx="2">
                  <c:v>8.9164664543482056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60718936"/>
        <c:axId val="360718544"/>
      </c:barChart>
      <c:catAx>
        <c:axId val="3607189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60718544"/>
        <c:crosses val="autoZero"/>
        <c:auto val="1"/>
        <c:lblAlgn val="ctr"/>
        <c:lblOffset val="100"/>
        <c:noMultiLvlLbl val="0"/>
      </c:catAx>
      <c:valAx>
        <c:axId val="36071854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607189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r"/>
      <c:layout/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ECBD4-6896-40CB-A239-D35E5F76797E}" type="datetimeFigureOut">
              <a:rPr lang="en-NZ" smtClean="0"/>
              <a:t>2/01/2017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5E52C-91AF-46F4-8C40-761207BD00D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962824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ECBD4-6896-40CB-A239-D35E5F76797E}" type="datetimeFigureOut">
              <a:rPr lang="en-NZ" smtClean="0"/>
              <a:t>2/01/2017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5E52C-91AF-46F4-8C40-761207BD00D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0685797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ECBD4-6896-40CB-A239-D35E5F76797E}" type="datetimeFigureOut">
              <a:rPr lang="en-NZ" smtClean="0"/>
              <a:t>2/01/2017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5E52C-91AF-46F4-8C40-761207BD00D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4182270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ECBD4-6896-40CB-A239-D35E5F76797E}" type="datetimeFigureOut">
              <a:rPr lang="en-NZ" smtClean="0"/>
              <a:t>2/01/2017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5E52C-91AF-46F4-8C40-761207BD00D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6834631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ECBD4-6896-40CB-A239-D35E5F76797E}" type="datetimeFigureOut">
              <a:rPr lang="en-NZ" smtClean="0"/>
              <a:t>2/01/2017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5E52C-91AF-46F4-8C40-761207BD00D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4509354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ECBD4-6896-40CB-A239-D35E5F76797E}" type="datetimeFigureOut">
              <a:rPr lang="en-NZ" smtClean="0"/>
              <a:t>2/01/2017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5E52C-91AF-46F4-8C40-761207BD00D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0028881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ECBD4-6896-40CB-A239-D35E5F76797E}" type="datetimeFigureOut">
              <a:rPr lang="en-NZ" smtClean="0"/>
              <a:t>2/01/2017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5E52C-91AF-46F4-8C40-761207BD00D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3335476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ECBD4-6896-40CB-A239-D35E5F76797E}" type="datetimeFigureOut">
              <a:rPr lang="en-NZ" smtClean="0"/>
              <a:t>2/01/2017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5E52C-91AF-46F4-8C40-761207BD00D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9367534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ECBD4-6896-40CB-A239-D35E5F76797E}" type="datetimeFigureOut">
              <a:rPr lang="en-NZ" smtClean="0"/>
              <a:t>2/01/2017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5E52C-91AF-46F4-8C40-761207BD00D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2128168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ECBD4-6896-40CB-A239-D35E5F76797E}" type="datetimeFigureOut">
              <a:rPr lang="en-NZ" smtClean="0"/>
              <a:t>2/01/2017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5E52C-91AF-46F4-8C40-761207BD00D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4880157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ECBD4-6896-40CB-A239-D35E5F76797E}" type="datetimeFigureOut">
              <a:rPr lang="en-NZ" smtClean="0"/>
              <a:t>2/01/2017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5E52C-91AF-46F4-8C40-761207BD00D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9776009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1ECBD4-6896-40CB-A239-D35E5F76797E}" type="datetimeFigureOut">
              <a:rPr lang="en-NZ" smtClean="0"/>
              <a:t>2/01/2017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05E52C-91AF-46F4-8C40-761207BD00D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5705433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3290207" y="775606"/>
            <a:ext cx="4290502" cy="5780602"/>
            <a:chOff x="3290207" y="775606"/>
            <a:chExt cx="4290502" cy="5780602"/>
          </a:xfrm>
        </p:grpSpPr>
        <p:sp>
          <p:nvSpPr>
            <p:cNvPr id="4" name="TextBox 3"/>
            <p:cNvSpPr txBox="1"/>
            <p:nvPr/>
          </p:nvSpPr>
          <p:spPr>
            <a:xfrm>
              <a:off x="3290207" y="6279209"/>
              <a:ext cx="317939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</a:t>
              </a:r>
              <a:r>
                <a:rPr lang="en-NZ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3</a:t>
              </a:r>
              <a:endParaRPr lang="en-NZ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5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80407425"/>
                </p:ext>
              </p:extLst>
            </p:nvPr>
          </p:nvGraphicFramePr>
          <p:xfrm>
            <a:off x="3290207" y="775606"/>
            <a:ext cx="4290502" cy="243033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6" name="Chart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93300443"/>
                </p:ext>
              </p:extLst>
            </p:nvPr>
          </p:nvGraphicFramePr>
          <p:xfrm>
            <a:off x="3290207" y="3436013"/>
            <a:ext cx="4280099" cy="245161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17279941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Plant &amp; Food Research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shi Foster</dc:creator>
  <cp:lastModifiedBy>Toshi Foster</cp:lastModifiedBy>
  <cp:revision>1</cp:revision>
  <dcterms:created xsi:type="dcterms:W3CDTF">2017-01-01T23:34:32Z</dcterms:created>
  <dcterms:modified xsi:type="dcterms:W3CDTF">2017-01-01T23:35:45Z</dcterms:modified>
</cp:coreProperties>
</file>